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ED63D2-D3E5-46B7-8DF4-1591A70AE7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25DCF3-ACB5-427C-9888-EB4815456E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B6210E-226A-486A-87B1-949F89D48B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95B40-E1A3-41B5-8E52-95FDFBB4777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E0357-B012-44B7-95A6-D20275A663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E8C27-4B8C-4553-83FB-DDE1F84E7E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206962-AD6B-42E2-AF73-B2C52F0AD3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FC11EF-0EC4-43D5-967C-CA6921962E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2EDB3-1972-4125-BCA0-FE225B4DC7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056682-21D3-4D93-9B1F-90089B46F4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02BA32-9F0B-4992-8960-972347D1FD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8A417-64E3-46A0-A2FE-E407B51236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E60EC9-F91D-488A-9D78-1F90FD63DD60}" type="slidenum">
              <a:rPr b="0" lang="zh-CN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http://sas.ebioservice.com/DisplayChart?filename=jfreechart-onetime-42205.png"/>
          <p:cNvPicPr/>
          <p:nvPr/>
        </p:nvPicPr>
        <p:blipFill>
          <a:blip r:embed="rId1"/>
          <a:stretch/>
        </p:blipFill>
        <p:spPr>
          <a:xfrm>
            <a:off x="395280" y="620640"/>
            <a:ext cx="8256600" cy="6193080"/>
          </a:xfrm>
          <a:prstGeom prst="rect">
            <a:avLst/>
          </a:prstGeom>
          <a:ln w="0">
            <a:noFill/>
          </a:ln>
        </p:spPr>
      </p:pic>
      <p:sp>
        <p:nvSpPr>
          <p:cNvPr id="42" name="矩形 1"/>
          <p:cNvSpPr/>
          <p:nvPr/>
        </p:nvSpPr>
        <p:spPr>
          <a:xfrm>
            <a:off x="179280" y="44280"/>
            <a:ext cx="8856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O analysis for biological proces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 Upregulated genes 3 dpi in PR8-infected p53WT mice compared with PR8-infected p53KO mi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2" descr="http://sas.ebioservice.com/DisplayChart?filename=jfreechart-onetime-42192.png"/>
          <p:cNvPicPr/>
          <p:nvPr/>
        </p:nvPicPr>
        <p:blipFill>
          <a:blip r:embed="rId1"/>
          <a:stretch/>
        </p:blipFill>
        <p:spPr>
          <a:xfrm>
            <a:off x="1476360" y="571680"/>
            <a:ext cx="6551640" cy="6264000"/>
          </a:xfrm>
          <a:prstGeom prst="rect">
            <a:avLst/>
          </a:prstGeom>
          <a:ln w="0">
            <a:noFill/>
          </a:ln>
        </p:spPr>
      </p:pic>
      <p:sp>
        <p:nvSpPr>
          <p:cNvPr id="44" name="矩形 1"/>
          <p:cNvSpPr/>
          <p:nvPr/>
        </p:nvSpPr>
        <p:spPr>
          <a:xfrm>
            <a:off x="179280" y="44280"/>
            <a:ext cx="8856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O analysis for biological proces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 Downregulated genes 3 dpi in PR8-infected p53WT mice compared with PR8-infected p53KO mi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矩形 1"/>
          <p:cNvSpPr/>
          <p:nvPr/>
        </p:nvSpPr>
        <p:spPr>
          <a:xfrm>
            <a:off x="179280" y="44280"/>
            <a:ext cx="8856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O analysis for biological proces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 Upregulated genes 6 dpi in PR8-infected p53WT mice compared with PR8-infected p53KO mi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2" descr="http://sas.ebioservice.com/DisplayChart?filename=jfreechart-onetime-35783.png"/>
          <p:cNvPicPr/>
          <p:nvPr/>
        </p:nvPicPr>
        <p:blipFill>
          <a:blip r:embed="rId1"/>
          <a:stretch/>
        </p:blipFill>
        <p:spPr>
          <a:xfrm>
            <a:off x="611280" y="655560"/>
            <a:ext cx="8115120" cy="6086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Picture 2" descr="http://sas.ebioservice.com/DisplayChart?filename=jfreechart-onetime-42209.png"/>
          <p:cNvPicPr/>
          <p:nvPr/>
        </p:nvPicPr>
        <p:blipFill>
          <a:blip r:embed="rId1"/>
          <a:stretch/>
        </p:blipFill>
        <p:spPr>
          <a:xfrm>
            <a:off x="611280" y="571680"/>
            <a:ext cx="8226360" cy="6170400"/>
          </a:xfrm>
          <a:prstGeom prst="rect">
            <a:avLst/>
          </a:prstGeom>
          <a:ln w="0">
            <a:noFill/>
          </a:ln>
        </p:spPr>
      </p:pic>
      <p:sp>
        <p:nvSpPr>
          <p:cNvPr id="48" name="矩形 1"/>
          <p:cNvSpPr/>
          <p:nvPr/>
        </p:nvSpPr>
        <p:spPr>
          <a:xfrm>
            <a:off x="179280" y="44280"/>
            <a:ext cx="8856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O analysis for biological proces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 Downregulated genes 6 dpi in PR8-infected p53WT mice compared with PR8-infected p53KO mi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X X</cp:lastModifiedBy>
  <dcterms:modified xsi:type="dcterms:W3CDTF">2015-06-03T06:22:22Z</dcterms:modified>
  <cp:revision>84</cp:revision>
  <dc:subject/>
  <dc:title>幻灯片 1</dc:title>
</cp:coreProperties>
</file>